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7150100" cy="94503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A49EAC-0C71-4AD1-9BC4-E64B4DAF52A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7019DF-F6D3-4DEE-8946-E3AF98F144A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323050-8122-4528-8AC6-DF8F291C8AB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6E4860-4E6C-41AA-A31F-C90DFABF132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BD4B14-74B9-4D7F-8B4C-B70366CFA14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7345CD-0E50-42E0-82CE-FCDC1F33CC6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F7BD4F-5195-408D-86DE-C769C1067DE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CF0154-D4C9-4C44-B91D-BF1DB6AFBD1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C89FA9-7AED-44FA-9FD7-30B92BD56C2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146800-A766-4BB7-A2B1-68B4110DA9E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8F06C8-F378-4207-B6A5-85B18EE15E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802428-69FE-430E-9F51-AE48918EC8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082344D-A901-4D63-9E2B-AB39EE44B16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685800" y="609480"/>
            <a:ext cx="3614760" cy="601992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4865400" y="874800"/>
            <a:ext cx="39344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This is also true when clustering bot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Samples and term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189000" y="2365200"/>
            <a:ext cx="4779720" cy="57240"/>
          </a:xfrm>
          <a:prstGeom prst="rect">
            <a:avLst/>
          </a:prstGeom>
          <a:noFill/>
          <a:ln w="284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0440" bIns="104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304920" y="5118120"/>
            <a:ext cx="4800600" cy="293760"/>
          </a:xfrm>
          <a:prstGeom prst="rect">
            <a:avLst/>
          </a:prstGeom>
          <a:noFill/>
          <a:ln w="284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5005440" y="2705040"/>
            <a:ext cx="1317600" cy="13464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6322320" y="3470400"/>
            <a:ext cx="2919240" cy="311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These three clusters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with similar patter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shall be clustered together,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but are separated in the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whole clustering heatma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宋体"/>
              </a:rPr>
              <a:t>That is Why we need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宋体"/>
              </a:rPr>
              <a:t>pattern extract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宋体"/>
              </a:rPr>
              <a:t>to get all patterned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宋体"/>
              </a:rPr>
              <a:t>terms together easily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宋体"/>
              </a:rPr>
              <a:t>and completel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84320" y="2476440"/>
            <a:ext cx="4800600" cy="208080"/>
          </a:xfrm>
          <a:prstGeom prst="rect">
            <a:avLst/>
          </a:prstGeom>
          <a:noFill/>
          <a:ln w="284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4978440" y="2384280"/>
            <a:ext cx="1361880" cy="15811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 flipV="1">
            <a:off x="5192640" y="4212720"/>
            <a:ext cx="1143000" cy="11430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" descr=""/>
          <p:cNvPicPr/>
          <p:nvPr/>
        </p:nvPicPr>
        <p:blipFill>
          <a:blip r:embed="rId1"/>
          <a:stretch/>
        </p:blipFill>
        <p:spPr>
          <a:xfrm>
            <a:off x="430200" y="0"/>
            <a:ext cx="5645160" cy="5187960"/>
          </a:xfrm>
          <a:prstGeom prst="rect">
            <a:avLst/>
          </a:prstGeom>
          <a:ln w="0">
            <a:noFill/>
          </a:ln>
        </p:spPr>
      </p:pic>
      <p:sp>
        <p:nvSpPr>
          <p:cNvPr id="51" name=""/>
          <p:cNvSpPr/>
          <p:nvPr/>
        </p:nvSpPr>
        <p:spPr>
          <a:xfrm>
            <a:off x="2858040" y="528480"/>
            <a:ext cx="6002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Complete Result ONLY from PTW Extraction, n=28 term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2" name=""/>
          <p:cNvGraphicFramePr/>
          <p:nvPr/>
        </p:nvGraphicFramePr>
        <p:xfrm>
          <a:off x="274680" y="5249880"/>
          <a:ext cx="8531280" cy="1519200"/>
        </p:xfrm>
        <a:graphic>
          <a:graphicData uri="http://schemas.openxmlformats.org/drawingml/2006/table">
            <a:tbl>
              <a:tblPr/>
              <a:tblGrid>
                <a:gridCol w="1628640"/>
                <a:gridCol w="1195560"/>
                <a:gridCol w="1438200"/>
                <a:gridCol w="1446120"/>
                <a:gridCol w="1432080"/>
                <a:gridCol w="1390680"/>
              </a:tblGrid>
              <a:tr h="39852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ermNam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er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ycE_stroma_FDR_20perc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R_stroma_FDR_10perc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ycE_tumor_FDR20perc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R_tumor_FDR_10perc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c0c0c0"/>
                    </a:solidFill>
                  </a:tcPr>
                </a:tc>
              </a:tr>
              <a:tr h="2462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itotic anapha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O:000009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8453534014465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.5374200835968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985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mino acid and derivative metabolis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O:000651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.5608683063005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9395049997699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462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mino acid metabolis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O:00065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.77685402749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9801927403892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462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mine metabolis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O:000930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.0405218932020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9594000059523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53" name=""/>
          <p:cNvSpPr/>
          <p:nvPr/>
        </p:nvSpPr>
        <p:spPr>
          <a:xfrm>
            <a:off x="5421240" y="3895560"/>
            <a:ext cx="371808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The following terms in table only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Can get from Pattern Extract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(due to the uneven data magnitud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Or distribution?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58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04-09T02:54:03Z</dcterms:created>
  <dc:creator>Ming Yi</dc:creator>
  <dc:description/>
  <dc:language>en-US</dc:language>
  <cp:lastModifiedBy>MYI</cp:lastModifiedBy>
  <dcterms:modified xsi:type="dcterms:W3CDTF">2007-06-08T03:50:30Z</dcterms:modified>
  <cp:revision>354</cp:revision>
  <dc:subject/>
  <dc:title>Slide 1</dc:title>
</cp:coreProperties>
</file>